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20" d="100"/>
          <a:sy n="120" d="100"/>
        </p:scale>
        <p:origin x="1234" y="-14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4250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9803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33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9439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506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0138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7547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286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877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348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6124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93099-B429-4052-8F4E-0296C82C97D2}" type="datetimeFigureOut">
              <a:rPr lang="zh-CN" altLang="en-US" smtClean="0"/>
              <a:t>2022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4FBA5-D977-4EF7-8995-93B2822D7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7152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3CE18E1-0C7A-63F3-3D06-272FE26371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56168"/>
            <a:ext cx="6858000" cy="346995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D88C6A7-7A06-EA62-537E-1E3658B498C3}"/>
              </a:ext>
            </a:extLst>
          </p:cNvPr>
          <p:cNvSpPr txBox="1"/>
          <p:nvPr/>
        </p:nvSpPr>
        <p:spPr>
          <a:xfrm>
            <a:off x="514139" y="4489938"/>
            <a:ext cx="5829721" cy="5078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kumimoji="0" lang="en-US" altLang="zh-CN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1. </a:t>
            </a:r>
            <a:r>
              <a:rPr kumimoji="0" lang="en-US" altLang="zh-CN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mparison of up-regulated genes and down-regulated genes distribution at GO level.</a:t>
            </a:r>
            <a:r>
              <a:rPr kumimoji="0" lang="en-US" altLang="zh-CN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en-US" altLang="zh-CN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he X axis is the GO item name, and the Y axis is the number and percentage of genes corresponding to the item.</a:t>
            </a:r>
            <a:endParaRPr lang="zh-CN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4319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CABD15A-6645-9A88-7D8D-08235B4C6B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53643"/>
            <a:ext cx="6858000" cy="495635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525BFC8-9937-06B5-2A89-66A49FEFEFBF}"/>
              </a:ext>
            </a:extLst>
          </p:cNvPr>
          <p:cNvSpPr txBox="1"/>
          <p:nvPr/>
        </p:nvSpPr>
        <p:spPr>
          <a:xfrm>
            <a:off x="514139" y="5754858"/>
            <a:ext cx="5829721" cy="84638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kumimoji="0" lang="en-US" altLang="zh-CN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2. </a:t>
            </a:r>
            <a:r>
              <a:rPr kumimoji="0" lang="en-US" altLang="zh-CN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stribution of DEGs at KEGG. The X-axis is the ratio (%) of the up-regulated (down-regulated) differentially expressed genes annotated to each metabolic pathway and the total number of DEGs annotated to the KEGG pathway. The Y axis represents the name of the pathway, and the number on the right side of the column represents DEGs annotated to the pathway.</a:t>
            </a:r>
            <a:endParaRPr lang="zh-CN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988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Words>108</Words>
  <Application>Microsoft Office PowerPoint</Application>
  <PresentationFormat>全屏显示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魏 文波</dc:creator>
  <cp:lastModifiedBy>魏 文波</cp:lastModifiedBy>
  <cp:revision>5</cp:revision>
  <dcterms:created xsi:type="dcterms:W3CDTF">2022-07-18T05:47:05Z</dcterms:created>
  <dcterms:modified xsi:type="dcterms:W3CDTF">2022-07-28T11:49:52Z</dcterms:modified>
</cp:coreProperties>
</file>